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4A833-27C7-4042-AC5B-75562815C9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DCCCEF-C754-4E92-A85B-24349C08EB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26CBC5-8E41-47C0-B4CD-781B3E575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3C15F1-B12A-4C86-AB67-A8A650217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FA3B0-37C0-48B2-B97F-8EC2AEECD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839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1F2B7-9456-4C48-8936-FD4067C8A9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67ECBA-EA07-40C0-9866-13D4372300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78F02B-7D8C-4F9B-BEAE-03E7E5E2F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D839D-3F1A-4178-A9C3-423965254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19811-9B16-44E8-9C05-8C8979B8A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99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181637-4CF2-4FBB-9D4B-23D336B715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504CF2-F6C4-4FA9-BFA5-460C1BF53B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98A4F2-CCD0-4D67-8D73-7571679AF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7916E2-23E6-43F8-B8DE-AAAC02F40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0ECD6B-E4FF-45C1-9396-92B129054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778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38C64-399C-4741-8036-13428D5C1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744C58-5F44-4AAF-8FA9-15A0CD1775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506463-44B3-4CAE-8C84-8CD192023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802D9-35C2-46DD-8997-0B4F5A6A4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E0F980-5A55-4582-9D8D-1565A6AF6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985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4C3BFD-C1FF-4FED-B0FF-D2629D81D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54F58F-2FB0-4F4D-B67F-954E473644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EFE958-97D2-4CBE-BEDC-DD12A49E1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9AF62-7547-4C6C-B2F2-3B8119320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CC721A-131F-4488-AF83-F45531F47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12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EE87F-DD0E-49AF-AB4C-CBA158D08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230704-F4D1-4CE8-B234-1271761ED2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1CB4EF-7289-4175-B90D-289FFE7C47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B1519D-CFE7-47F6-ACC8-097C5557E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74B2EC-37DD-4216-A12D-51FD3DEAA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973E6E-F436-4066-A46B-418E7006E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41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1500D0-3043-4B4F-B841-A7A0E70EC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E5D067-4FED-44A2-851B-1F9ADBAFFC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290198-469A-45E8-9C7D-D81627C10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8AE4C0-44F2-4FD0-ABC7-4398324D12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FFA942-CE04-419B-B55C-BFB137E0DA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0E28C4-D978-442D-8D18-26CBE089D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0B84D0-8A7C-4269-9CC8-F69260CAF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2E421D-1907-434A-B29A-ACB3E9F4B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86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858E9-CC40-4B7F-8FC4-30A3EB79E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D45F8C-9409-4F62-A1B6-207DA0243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AB4824-7D9F-4773-B66D-5E6412BB1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D88B2A-E8A9-46D2-99BB-6663CCBB1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958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5CE09A-D330-4ACB-ABC6-8DCED17AF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3224E6-9A8D-41F8-BE29-F9566D797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CE5455-6C3B-47EA-8E3B-958E974FD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046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1CAB0-3D36-45CD-9AF0-C761F955D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337809-FAD4-4569-A392-63F246C854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012C43-05D2-4B72-AE84-DC4EE81973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2CF818-E53B-423D-85FF-BB4563A63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0376ED-F89B-40CD-919C-83E5252DD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0E2C2F-CD2D-4E4F-ADB9-FAD73DCF3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355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A5093-735F-4331-AB72-96338A021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8365ED-E7BC-43B3-88FA-0E811EC9FC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CCD928-3934-436C-8FF7-88D7B510EC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DA2A53-F4E2-4544-9D8C-485DD4DB0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C34C6A-8F04-4DDB-BD7C-4693CE35D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2DBBB3-93CB-4D43-BE4A-1B61A1780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75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1753E3-137C-416E-AAF2-60186CB358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96521C-7BB2-42CA-A26F-FDAFD2EAE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B6E18-1203-4327-8349-3DF48C0A10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141E1-3607-4900-87FE-41B174E267F2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E13AF6-5508-4906-A268-F8EB941FB6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CAF254-9EF1-4B1A-A474-44E6EC5566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4081E-9A72-422A-BDE0-E9C6568A0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885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5DF4D2-584D-4830-AF83-137541B176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9560"/>
          <a:stretch/>
        </p:blipFill>
        <p:spPr>
          <a:xfrm>
            <a:off x="2880575" y="896722"/>
            <a:ext cx="5593725" cy="4046205"/>
          </a:xfrm>
          <a:prstGeom prst="rect">
            <a:avLst/>
          </a:prstGeom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640170" y="857251"/>
          <a:ext cx="5936649" cy="50552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36649">
                  <a:extLst>
                    <a:ext uri="{9D8B030D-6E8A-4147-A177-3AD203B41FA5}">
                      <a16:colId xmlns:a16="http://schemas.microsoft.com/office/drawing/2014/main" val="2891490085"/>
                    </a:ext>
                  </a:extLst>
                </a:gridCol>
              </a:tblGrid>
              <a:tr h="4163720"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7681369"/>
                  </a:ext>
                </a:extLst>
              </a:tr>
              <a:tr h="8915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Supplemental Figure 2.</a:t>
                      </a:r>
                      <a:r>
                        <a:rPr lang="en-US" sz="800" b="0" dirty="0">
                          <a:latin typeface="Arial"/>
                          <a:cs typeface="Arial"/>
                        </a:rPr>
                        <a:t> Visual representation of bioluminescence. Representative </a:t>
                      </a:r>
                      <a:r>
                        <a:rPr lang="en-US" sz="800" b="0" i="1" dirty="0">
                          <a:latin typeface="Arial"/>
                          <a:cs typeface="Arial"/>
                        </a:rPr>
                        <a:t>in vivo S. aureus </a:t>
                      </a:r>
                      <a:r>
                        <a:rPr lang="en-US" sz="800" b="0" dirty="0">
                          <a:latin typeface="Arial"/>
                          <a:cs typeface="Arial"/>
                        </a:rPr>
                        <a:t>bioluminescence on a color scale overlaid on top of a grayscale image of mice. Wound breakdown occurred in 1*10</a:t>
                      </a:r>
                      <a:r>
                        <a:rPr lang="en-US" sz="800" b="0" baseline="30000" dirty="0">
                          <a:latin typeface="Arial"/>
                          <a:cs typeface="Arial"/>
                        </a:rPr>
                        <a:t>4 </a:t>
                      </a:r>
                      <a:r>
                        <a:rPr lang="en-US" sz="800" b="0" baseline="0" dirty="0">
                          <a:latin typeface="Arial"/>
                          <a:cs typeface="Arial"/>
                        </a:rPr>
                        <a:t>groups after POD7, and in 1*10</a:t>
                      </a:r>
                      <a:r>
                        <a:rPr lang="en-US" sz="800" b="0" baseline="30000" dirty="0">
                          <a:latin typeface="Arial"/>
                          <a:cs typeface="Arial"/>
                        </a:rPr>
                        <a:t>3</a:t>
                      </a:r>
                      <a:r>
                        <a:rPr lang="en-US" sz="800" b="0" baseline="0" dirty="0">
                          <a:latin typeface="Arial"/>
                          <a:cs typeface="Arial"/>
                        </a:rPr>
                        <a:t> groups after POD42.</a:t>
                      </a:r>
                      <a:r>
                        <a:rPr lang="en-US" sz="800" b="0" dirty="0">
                          <a:latin typeface="Arial"/>
                          <a:cs typeface="Arial"/>
                        </a:rPr>
                        <a:t> *: Mouse was imaged on POD7 due to wound breakdown.</a:t>
                      </a: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49441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82973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3</cp:revision>
  <dcterms:created xsi:type="dcterms:W3CDTF">2020-08-22T04:21:20Z</dcterms:created>
  <dcterms:modified xsi:type="dcterms:W3CDTF">2020-08-22T04:54:41Z</dcterms:modified>
</cp:coreProperties>
</file>